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16" d="100"/>
          <a:sy n="116" d="100"/>
        </p:scale>
        <p:origin x="-352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5DA5-46C0-8BB2-FC325524AAF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5DA5-46C0-8BB2-FC325524AAFC}"/>
              </c:ext>
            </c:extLst>
          </c:dPt>
          <c:dPt>
            <c:idx val="3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5DA5-46C0-8BB2-FC325524AAFC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5DA5-46C0-8BB2-FC325524AAFC}"/>
              </c:ext>
            </c:extLst>
          </c:dPt>
          <c:cat>
            <c:numRef>
              <c:f>'NOG 特異的IgG'!$C$12:$C$17</c:f>
              <c:numCache>
                <c:formatCode>General</c:formatCode>
                <c:ptCount val="6"/>
                <c:pt idx="0">
                  <c:v>1.0</c:v>
                </c:pt>
                <c:pt idx="1">
                  <c:v>2.0</c:v>
                </c:pt>
                <c:pt idx="2">
                  <c:v>3.0</c:v>
                </c:pt>
                <c:pt idx="3">
                  <c:v>4.0</c:v>
                </c:pt>
                <c:pt idx="4">
                  <c:v>5.0</c:v>
                </c:pt>
                <c:pt idx="5">
                  <c:v>6.0</c:v>
                </c:pt>
              </c:numCache>
            </c:numRef>
          </c:cat>
          <c:val>
            <c:numRef>
              <c:f>'NOG 特異的IgG'!$E$12:$E$17</c:f>
              <c:numCache>
                <c:formatCode>General</c:formatCode>
                <c:ptCount val="6"/>
                <c:pt idx="0">
                  <c:v>168.6</c:v>
                </c:pt>
                <c:pt idx="1">
                  <c:v>162.0</c:v>
                </c:pt>
                <c:pt idx="2">
                  <c:v>0.0</c:v>
                </c:pt>
                <c:pt idx="3">
                  <c:v>6.827999999999993</c:v>
                </c:pt>
                <c:pt idx="4">
                  <c:v>1.532</c:v>
                </c:pt>
                <c:pt idx="5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5DA5-46C0-8BB2-FC325524AA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2"/>
        <c:axId val="2124920744"/>
        <c:axId val="-2135997976"/>
      </c:barChart>
      <c:catAx>
        <c:axId val="212492074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2135997976"/>
        <c:crosses val="autoZero"/>
        <c:auto val="1"/>
        <c:lblAlgn val="ctr"/>
        <c:lblOffset val="100"/>
        <c:noMultiLvlLbl val="0"/>
      </c:catAx>
      <c:valAx>
        <c:axId val="-21359979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24920744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5862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9789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62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4032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1491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9874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3612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0855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5002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8000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E2C8B-4761-4D08-9E9F-8F135B30B4AF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5283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E2C8B-4761-4D08-9E9F-8F135B30B4AF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24434B-FBE0-4BEA-BC06-FD3677F38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4512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図形グループ 16"/>
          <p:cNvGrpSpPr/>
          <p:nvPr/>
        </p:nvGrpSpPr>
        <p:grpSpPr>
          <a:xfrm>
            <a:off x="777537" y="2590914"/>
            <a:ext cx="5373597" cy="4035247"/>
            <a:chOff x="1057347" y="1239473"/>
            <a:chExt cx="6730176" cy="4740850"/>
          </a:xfrm>
        </p:grpSpPr>
        <p:graphicFrame>
          <p:nvGraphicFramePr>
            <p:cNvPr id="18" name="グラフ 17">
              <a:extLst>
                <a:ext uri="{FF2B5EF4-FFF2-40B4-BE49-F238E27FC236}">
                  <a16:creationId xmlns:a16="http://schemas.microsoft.com/office/drawing/2014/main" xmlns="" id="{33BD323B-8B7E-46B0-BCC7-7000CBCD2A4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09050647"/>
                </p:ext>
              </p:extLst>
            </p:nvPr>
          </p:nvGraphicFramePr>
          <p:xfrm>
            <a:off x="1365123" y="1239473"/>
            <a:ext cx="6422400" cy="4370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9" name="テキスト ボックス 18"/>
            <p:cNvSpPr txBox="1"/>
            <p:nvPr/>
          </p:nvSpPr>
          <p:spPr>
            <a:xfrm rot="16200000">
              <a:off x="-362721" y="3270784"/>
              <a:ext cx="31479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CH401MAP specific IgG (</a:t>
              </a:r>
              <a:r>
                <a:rPr kumimoji="1" lang="en-US" altLang="ja-JP" sz="1400" dirty="0" err="1"/>
                <a:t>pg</a:t>
              </a:r>
              <a:r>
                <a:rPr kumimoji="1" lang="en-US" altLang="ja-JP" sz="1400" dirty="0"/>
                <a:t>/ml)</a:t>
              </a:r>
              <a:endParaRPr kumimoji="1" lang="ja-JP" altLang="en-US" sz="1400" dirty="0"/>
            </a:p>
          </p:txBody>
        </p:sp>
        <p:sp>
          <p:nvSpPr>
            <p:cNvPr id="20" name="正方形/長方形 19"/>
            <p:cNvSpPr/>
            <p:nvPr/>
          </p:nvSpPr>
          <p:spPr>
            <a:xfrm>
              <a:off x="6038591" y="1497187"/>
              <a:ext cx="1322923" cy="500343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 dirty="0">
                <a:latin typeface="+mn-ea"/>
              </a:endParaRPr>
            </a:p>
          </p:txBody>
        </p:sp>
        <p:sp>
          <p:nvSpPr>
            <p:cNvPr id="21" name="正方形/長方形 20"/>
            <p:cNvSpPr/>
            <p:nvPr/>
          </p:nvSpPr>
          <p:spPr>
            <a:xfrm>
              <a:off x="6151564" y="1779643"/>
              <a:ext cx="148760" cy="14876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+mn-ea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6264300" y="1723206"/>
              <a:ext cx="1368680" cy="325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+mn-ea"/>
                  <a:cs typeface="メイリオ" panose="020B0604030504040204" pitchFamily="50" charset="-128"/>
                </a:rPr>
                <a:t>CH401MAP</a:t>
              </a:r>
              <a:endParaRPr kumimoji="1" lang="ja-JP" altLang="en-US" sz="1200" dirty="0">
                <a:latin typeface="+mn-ea"/>
                <a:cs typeface="メイリオ" panose="020B0604030504040204" pitchFamily="50" charset="-128"/>
              </a:endParaRPr>
            </a:p>
          </p:txBody>
        </p:sp>
        <p:sp>
          <p:nvSpPr>
            <p:cNvPr id="23" name="正方形/長方形 22"/>
            <p:cNvSpPr/>
            <p:nvPr/>
          </p:nvSpPr>
          <p:spPr>
            <a:xfrm>
              <a:off x="6151564" y="1547176"/>
              <a:ext cx="148760" cy="14876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+mn-ea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6255188" y="1490739"/>
              <a:ext cx="1368680" cy="325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+mn-ea"/>
                  <a:cs typeface="メイリオ" panose="020B0604030504040204" pitchFamily="50" charset="-128"/>
                </a:rPr>
                <a:t>PBS</a:t>
              </a:r>
              <a:endParaRPr kumimoji="1" lang="ja-JP" altLang="en-US" sz="1200" dirty="0">
                <a:latin typeface="+mn-ea"/>
                <a:cs typeface="メイリオ" panose="020B0604030504040204" pitchFamily="50" charset="-128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2314002" y="5609873"/>
              <a:ext cx="9787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HD32</a:t>
              </a:r>
              <a:endParaRPr kumimoji="1" lang="ja-JP" altLang="en-US" dirty="0"/>
            </a:p>
          </p:txBody>
        </p:sp>
        <p:sp>
          <p:nvSpPr>
            <p:cNvPr id="26" name="フリーフォーム: 図形 9"/>
            <p:cNvSpPr/>
            <p:nvPr/>
          </p:nvSpPr>
          <p:spPr>
            <a:xfrm>
              <a:off x="2163954" y="5475431"/>
              <a:ext cx="1278892" cy="163405"/>
            </a:xfrm>
            <a:custGeom>
              <a:avLst/>
              <a:gdLst>
                <a:gd name="connsiteX0" fmla="*/ 0 w 5872767"/>
                <a:gd name="connsiteY0" fmla="*/ 0 h 682580"/>
                <a:gd name="connsiteX1" fmla="*/ 12879 w 5872767"/>
                <a:gd name="connsiteY1" fmla="*/ 682580 h 682580"/>
                <a:gd name="connsiteX2" fmla="*/ 5859888 w 5872767"/>
                <a:gd name="connsiteY2" fmla="*/ 682580 h 682580"/>
                <a:gd name="connsiteX3" fmla="*/ 5872767 w 5872767"/>
                <a:gd name="connsiteY3" fmla="*/ 12879 h 682580"/>
                <a:gd name="connsiteX0" fmla="*/ 0 w 5875791"/>
                <a:gd name="connsiteY0" fmla="*/ 0 h 682580"/>
                <a:gd name="connsiteX1" fmla="*/ 12879 w 5875791"/>
                <a:gd name="connsiteY1" fmla="*/ 682580 h 682580"/>
                <a:gd name="connsiteX2" fmla="*/ 5875791 w 5875791"/>
                <a:gd name="connsiteY2" fmla="*/ 682580 h 682580"/>
                <a:gd name="connsiteX3" fmla="*/ 5872767 w 5875791"/>
                <a:gd name="connsiteY3" fmla="*/ 12879 h 682580"/>
                <a:gd name="connsiteX0" fmla="*/ 3023 w 5878814"/>
                <a:gd name="connsiteY0" fmla="*/ 0 h 682580"/>
                <a:gd name="connsiteX1" fmla="*/ 0 w 5878814"/>
                <a:gd name="connsiteY1" fmla="*/ 682580 h 682580"/>
                <a:gd name="connsiteX2" fmla="*/ 5878814 w 5878814"/>
                <a:gd name="connsiteY2" fmla="*/ 682580 h 682580"/>
                <a:gd name="connsiteX3" fmla="*/ 5875790 w 5878814"/>
                <a:gd name="connsiteY3" fmla="*/ 12879 h 682580"/>
                <a:gd name="connsiteX0" fmla="*/ 101 w 5875892"/>
                <a:gd name="connsiteY0" fmla="*/ 0 h 682580"/>
                <a:gd name="connsiteX1" fmla="*/ 5029 w 5875892"/>
                <a:gd name="connsiteY1" fmla="*/ 682580 h 682580"/>
                <a:gd name="connsiteX2" fmla="*/ 5875892 w 5875892"/>
                <a:gd name="connsiteY2" fmla="*/ 682580 h 682580"/>
                <a:gd name="connsiteX3" fmla="*/ 5872868 w 5875892"/>
                <a:gd name="connsiteY3" fmla="*/ 12879 h 682580"/>
                <a:gd name="connsiteX0" fmla="*/ 6291 w 5882082"/>
                <a:gd name="connsiteY0" fmla="*/ 0 h 682580"/>
                <a:gd name="connsiteX1" fmla="*/ 0 w 5882082"/>
                <a:gd name="connsiteY1" fmla="*/ 682580 h 682580"/>
                <a:gd name="connsiteX2" fmla="*/ 5882082 w 5882082"/>
                <a:gd name="connsiteY2" fmla="*/ 682580 h 682580"/>
                <a:gd name="connsiteX3" fmla="*/ 5879058 w 5882082"/>
                <a:gd name="connsiteY3" fmla="*/ 12879 h 682580"/>
                <a:gd name="connsiteX0" fmla="*/ 682 w 5876473"/>
                <a:gd name="connsiteY0" fmla="*/ 0 h 682580"/>
                <a:gd name="connsiteX1" fmla="*/ 0 w 5876473"/>
                <a:gd name="connsiteY1" fmla="*/ 682580 h 682580"/>
                <a:gd name="connsiteX2" fmla="*/ 5876473 w 5876473"/>
                <a:gd name="connsiteY2" fmla="*/ 682580 h 682580"/>
                <a:gd name="connsiteX3" fmla="*/ 5873449 w 5876473"/>
                <a:gd name="connsiteY3" fmla="*/ 12879 h 6825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5876473" h="682580">
                  <a:moveTo>
                    <a:pt x="682" y="0"/>
                  </a:moveTo>
                  <a:cubicBezTo>
                    <a:pt x="-326" y="227527"/>
                    <a:pt x="1008" y="455053"/>
                    <a:pt x="0" y="682580"/>
                  </a:cubicBezTo>
                  <a:lnTo>
                    <a:pt x="5876473" y="682580"/>
                  </a:lnTo>
                  <a:lnTo>
                    <a:pt x="5873449" y="12879"/>
                  </a:ln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5765792" y="5610991"/>
              <a:ext cx="9787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HD33</a:t>
              </a:r>
              <a:endParaRPr kumimoji="1" lang="ja-JP" altLang="en-US" dirty="0"/>
            </a:p>
          </p:txBody>
        </p:sp>
        <p:sp>
          <p:nvSpPr>
            <p:cNvPr id="28" name="フリーフォーム: 図形 11"/>
            <p:cNvSpPr/>
            <p:nvPr/>
          </p:nvSpPr>
          <p:spPr>
            <a:xfrm>
              <a:off x="5318975" y="5476549"/>
              <a:ext cx="1872426" cy="163405"/>
            </a:xfrm>
            <a:custGeom>
              <a:avLst/>
              <a:gdLst>
                <a:gd name="connsiteX0" fmla="*/ 0 w 5872767"/>
                <a:gd name="connsiteY0" fmla="*/ 0 h 682580"/>
                <a:gd name="connsiteX1" fmla="*/ 12879 w 5872767"/>
                <a:gd name="connsiteY1" fmla="*/ 682580 h 682580"/>
                <a:gd name="connsiteX2" fmla="*/ 5859888 w 5872767"/>
                <a:gd name="connsiteY2" fmla="*/ 682580 h 682580"/>
                <a:gd name="connsiteX3" fmla="*/ 5872767 w 5872767"/>
                <a:gd name="connsiteY3" fmla="*/ 12879 h 682580"/>
                <a:gd name="connsiteX0" fmla="*/ 0 w 5875791"/>
                <a:gd name="connsiteY0" fmla="*/ 0 h 682580"/>
                <a:gd name="connsiteX1" fmla="*/ 12879 w 5875791"/>
                <a:gd name="connsiteY1" fmla="*/ 682580 h 682580"/>
                <a:gd name="connsiteX2" fmla="*/ 5875791 w 5875791"/>
                <a:gd name="connsiteY2" fmla="*/ 682580 h 682580"/>
                <a:gd name="connsiteX3" fmla="*/ 5872767 w 5875791"/>
                <a:gd name="connsiteY3" fmla="*/ 12879 h 682580"/>
                <a:gd name="connsiteX0" fmla="*/ 3023 w 5878814"/>
                <a:gd name="connsiteY0" fmla="*/ 0 h 682580"/>
                <a:gd name="connsiteX1" fmla="*/ 0 w 5878814"/>
                <a:gd name="connsiteY1" fmla="*/ 682580 h 682580"/>
                <a:gd name="connsiteX2" fmla="*/ 5878814 w 5878814"/>
                <a:gd name="connsiteY2" fmla="*/ 682580 h 682580"/>
                <a:gd name="connsiteX3" fmla="*/ 5875790 w 5878814"/>
                <a:gd name="connsiteY3" fmla="*/ 12879 h 682580"/>
                <a:gd name="connsiteX0" fmla="*/ 101 w 5875892"/>
                <a:gd name="connsiteY0" fmla="*/ 0 h 682580"/>
                <a:gd name="connsiteX1" fmla="*/ 5029 w 5875892"/>
                <a:gd name="connsiteY1" fmla="*/ 682580 h 682580"/>
                <a:gd name="connsiteX2" fmla="*/ 5875892 w 5875892"/>
                <a:gd name="connsiteY2" fmla="*/ 682580 h 682580"/>
                <a:gd name="connsiteX3" fmla="*/ 5872868 w 5875892"/>
                <a:gd name="connsiteY3" fmla="*/ 12879 h 682580"/>
                <a:gd name="connsiteX0" fmla="*/ 6291 w 5882082"/>
                <a:gd name="connsiteY0" fmla="*/ 0 h 682580"/>
                <a:gd name="connsiteX1" fmla="*/ 0 w 5882082"/>
                <a:gd name="connsiteY1" fmla="*/ 682580 h 682580"/>
                <a:gd name="connsiteX2" fmla="*/ 5882082 w 5882082"/>
                <a:gd name="connsiteY2" fmla="*/ 682580 h 682580"/>
                <a:gd name="connsiteX3" fmla="*/ 5879058 w 5882082"/>
                <a:gd name="connsiteY3" fmla="*/ 12879 h 682580"/>
                <a:gd name="connsiteX0" fmla="*/ 682 w 5876473"/>
                <a:gd name="connsiteY0" fmla="*/ 0 h 682580"/>
                <a:gd name="connsiteX1" fmla="*/ 0 w 5876473"/>
                <a:gd name="connsiteY1" fmla="*/ 682580 h 682580"/>
                <a:gd name="connsiteX2" fmla="*/ 5876473 w 5876473"/>
                <a:gd name="connsiteY2" fmla="*/ 682580 h 682580"/>
                <a:gd name="connsiteX3" fmla="*/ 5873449 w 5876473"/>
                <a:gd name="connsiteY3" fmla="*/ 12879 h 6825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5876473" h="682580">
                  <a:moveTo>
                    <a:pt x="682" y="0"/>
                  </a:moveTo>
                  <a:cubicBezTo>
                    <a:pt x="-326" y="227527"/>
                    <a:pt x="1008" y="455053"/>
                    <a:pt x="0" y="682580"/>
                  </a:cubicBezTo>
                  <a:lnTo>
                    <a:pt x="5876473" y="682580"/>
                  </a:lnTo>
                  <a:lnTo>
                    <a:pt x="5873449" y="12879"/>
                  </a:ln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6800427" y="5162689"/>
              <a:ext cx="5147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D</a:t>
              </a:r>
              <a:endParaRPr kumimoji="1" lang="ja-JP" altLang="en-US" sz="1400" dirty="0"/>
            </a:p>
          </p:txBody>
        </p:sp>
      </p:grpSp>
      <p:sp>
        <p:nvSpPr>
          <p:cNvPr id="30" name="テキスト ボックス 29"/>
          <p:cNvSpPr txBox="1"/>
          <p:nvPr/>
        </p:nvSpPr>
        <p:spPr>
          <a:xfrm>
            <a:off x="499157" y="1840577"/>
            <a:ext cx="6053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/>
              <a:t>Serum level of CH401MAP-specific </a:t>
            </a:r>
            <a:r>
              <a:rPr kumimoji="1" lang="en-US" altLang="ja-JP" dirty="0" err="1" smtClean="0"/>
              <a:t>IgG</a:t>
            </a:r>
            <a:r>
              <a:rPr kumimoji="1" lang="en-US" altLang="ja-JP" dirty="0" smtClean="0"/>
              <a:t> in NOG mouse</a:t>
            </a:r>
            <a:endParaRPr kumimoji="1" lang="ja-JP" altLang="en-US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739453" y="6888797"/>
            <a:ext cx="28805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ND: </a:t>
            </a:r>
            <a:r>
              <a:rPr kumimoji="1" lang="en-US" altLang="ja-JP" sz="1200" dirty="0" smtClean="0"/>
              <a:t>The mouse was dead </a:t>
            </a:r>
            <a:r>
              <a:rPr kumimoji="1" lang="en-US" altLang="ja-JP" sz="1200" dirty="0"/>
              <a:t>by GVHD before 2 weeks</a:t>
            </a:r>
            <a:endParaRPr kumimoji="1" lang="ja-JP" altLang="en-US" sz="12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" y="-15552"/>
            <a:ext cx="1052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Fig. </a:t>
            </a:r>
            <a:r>
              <a:rPr kumimoji="1" lang="en-US" altLang="ja-JP" smtClean="0"/>
              <a:t>S7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76125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1</TotalTime>
  <Words>37</Words>
  <Application>Microsoft Macintosh PowerPoint</Application>
  <PresentationFormat>画面に合わせる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本 あすか</dc:creator>
  <cp:lastModifiedBy>Kametani Yoshie</cp:lastModifiedBy>
  <cp:revision>13</cp:revision>
  <dcterms:created xsi:type="dcterms:W3CDTF">2017-04-17T10:34:15Z</dcterms:created>
  <dcterms:modified xsi:type="dcterms:W3CDTF">2017-05-07T11:50:14Z</dcterms:modified>
</cp:coreProperties>
</file>